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20" d="100"/>
          <a:sy n="120" d="100"/>
        </p:scale>
        <p:origin x="-2382" y="1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49007-2920-4583-8F2C-80BC05E7875A}" type="datetimeFigureOut">
              <a:rPr kumimoji="1" lang="ja-JP" altLang="en-US" smtClean="0"/>
              <a:t>2021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5DDC3-5B1F-4E99-B014-19ED787E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717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49007-2920-4583-8F2C-80BC05E7875A}" type="datetimeFigureOut">
              <a:rPr kumimoji="1" lang="ja-JP" altLang="en-US" smtClean="0"/>
              <a:t>2021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5DDC3-5B1F-4E99-B014-19ED787E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495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49007-2920-4583-8F2C-80BC05E7875A}" type="datetimeFigureOut">
              <a:rPr kumimoji="1" lang="ja-JP" altLang="en-US" smtClean="0"/>
              <a:t>2021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5DDC3-5B1F-4E99-B014-19ED787E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6911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49007-2920-4583-8F2C-80BC05E7875A}" type="datetimeFigureOut">
              <a:rPr kumimoji="1" lang="ja-JP" altLang="en-US" smtClean="0"/>
              <a:t>2021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5DDC3-5B1F-4E99-B014-19ED787E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995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49007-2920-4583-8F2C-80BC05E7875A}" type="datetimeFigureOut">
              <a:rPr kumimoji="1" lang="ja-JP" altLang="en-US" smtClean="0"/>
              <a:t>2021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5DDC3-5B1F-4E99-B014-19ED787E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733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49007-2920-4583-8F2C-80BC05E7875A}" type="datetimeFigureOut">
              <a:rPr kumimoji="1" lang="ja-JP" altLang="en-US" smtClean="0"/>
              <a:t>2021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5DDC3-5B1F-4E99-B014-19ED787E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0915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49007-2920-4583-8F2C-80BC05E7875A}" type="datetimeFigureOut">
              <a:rPr kumimoji="1" lang="ja-JP" altLang="en-US" smtClean="0"/>
              <a:t>2021/10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5DDC3-5B1F-4E99-B014-19ED787E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8175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49007-2920-4583-8F2C-80BC05E7875A}" type="datetimeFigureOut">
              <a:rPr kumimoji="1" lang="ja-JP" altLang="en-US" smtClean="0"/>
              <a:t>2021/10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5DDC3-5B1F-4E99-B014-19ED787E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9484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49007-2920-4583-8F2C-80BC05E7875A}" type="datetimeFigureOut">
              <a:rPr kumimoji="1" lang="ja-JP" altLang="en-US" smtClean="0"/>
              <a:t>2021/10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5DDC3-5B1F-4E99-B014-19ED787E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7012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49007-2920-4583-8F2C-80BC05E7875A}" type="datetimeFigureOut">
              <a:rPr kumimoji="1" lang="ja-JP" altLang="en-US" smtClean="0"/>
              <a:t>2021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5DDC3-5B1F-4E99-B014-19ED787E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98312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49007-2920-4583-8F2C-80BC05E7875A}" type="datetimeFigureOut">
              <a:rPr kumimoji="1" lang="ja-JP" altLang="en-US" smtClean="0"/>
              <a:t>2021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5DDC3-5B1F-4E99-B014-19ED787E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688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549007-2920-4583-8F2C-80BC05E7875A}" type="datetimeFigureOut">
              <a:rPr kumimoji="1" lang="ja-JP" altLang="en-US" smtClean="0"/>
              <a:t>2021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5DDC3-5B1F-4E99-B014-19ED787EE6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953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48680" y="1491660"/>
            <a:ext cx="2920632" cy="347787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PLD1-F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PLD1-R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PLD2-F1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PLD2-R1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PLD3-F1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PLD3-R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GT14-F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GT14-R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VWA1-F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VWA1-R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VWA2-F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VWA2-R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SIG-F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SIG-R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PsbQ-F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PsbQ-R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Aly-F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Aly-R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18S-F1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y18S-R1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線コネクタ 2"/>
          <p:cNvCxnSpPr/>
          <p:nvPr/>
        </p:nvCxnSpPr>
        <p:spPr>
          <a:xfrm flipV="1">
            <a:off x="476672" y="1205955"/>
            <a:ext cx="5796000" cy="155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正方形/長方形 1"/>
          <p:cNvSpPr/>
          <p:nvPr/>
        </p:nvSpPr>
        <p:spPr>
          <a:xfrm>
            <a:off x="374451" y="910625"/>
            <a:ext cx="607888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fr-FR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list of primers used for gene expression analysis by quantitative Real Time PCR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551096" y="1207510"/>
            <a:ext cx="583023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name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　　　　　　　　　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D                                               Sequence (5’-3’)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線コネクタ 5"/>
          <p:cNvCxnSpPr/>
          <p:nvPr/>
        </p:nvCxnSpPr>
        <p:spPr>
          <a:xfrm flipV="1">
            <a:off x="494184" y="1484509"/>
            <a:ext cx="5796000" cy="155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/>
          <p:nvPr/>
        </p:nvCxnSpPr>
        <p:spPr>
          <a:xfrm flipV="1">
            <a:off x="470597" y="4932040"/>
            <a:ext cx="5796000" cy="155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正方形/長方形 8"/>
          <p:cNvSpPr/>
          <p:nvPr/>
        </p:nvSpPr>
        <p:spPr>
          <a:xfrm>
            <a:off x="2276872" y="1482954"/>
            <a:ext cx="1452642" cy="34778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g_17468_g4270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g_17468_g4270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g_1916_g311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g_1916_g311</a:t>
            </a:r>
            <a:endParaRPr lang="en-US" altLang="ja-JP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1.g7400</a:t>
            </a:r>
            <a:endParaRPr lang="en-US" altLang="ja-JP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1.g7400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g_33528_g8098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g_33528_g8098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g_39034_g9071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g_39034_g9071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g_3234_g688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g_3234_g688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g_48204_g10361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g_48204_g10361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g_10995_g2626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g_10995_g2626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g_11106_g2658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g_11106_g2658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79976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79976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4136522" y="1482954"/>
            <a:ext cx="2180405" cy="36471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CAAGATTGCCCACAAGGT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CGCGAAGAACTGAAGGTAG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TCGGGTAAGGAGCTGAGTG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TTGGTAGAGCGTCACACG</a:t>
            </a:r>
            <a:endParaRPr lang="en-US" altLang="ja-JP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GTTCCAATTTCAGACGTT</a:t>
            </a:r>
            <a:endParaRPr lang="en-US" altLang="ja-JP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GTCTCGTTCTCAAACTCC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CAAGATACCCTCCGAGA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AGCTTCGATGGCAGAAA</a:t>
            </a:r>
            <a:endParaRPr lang="en-US" altLang="ja-JP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TTGATGGGAGTGTGGACT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CACGTCGAGTTTCTCAA</a:t>
            </a:r>
            <a:endParaRPr lang="en-US" altLang="ja-JP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ACATTACGCGTGCCACTG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CGTGATGGTCTGGGTAAG</a:t>
            </a:r>
            <a:endParaRPr lang="en-US" altLang="ja-JP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CACTCGGCAGCTTCATTG</a:t>
            </a:r>
            <a:endParaRPr lang="en-US" altLang="ja-JP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TCCTCCAGCGTCTTGAT</a:t>
            </a:r>
            <a:endParaRPr lang="en-US" altLang="ja-JP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CGACGACGAGAAGGACTAC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TGAGGTTGACTTGCGTCTG</a:t>
            </a:r>
            <a:endParaRPr lang="en-US" altLang="ja-JP" sz="11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GACATGGTGTTTGTCATGG</a:t>
            </a: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GCATCCACGTGAAGTGTTT</a:t>
            </a:r>
          </a:p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GGTTGATCCGCAGGGAAG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TTGCGCCCACTCCATTAG</a:t>
            </a:r>
          </a:p>
          <a:p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491182" y="4995498"/>
            <a:ext cx="208262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Accession number in </a:t>
            </a:r>
            <a:r>
              <a:rPr lang="en-US" altLang="ja-JP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Bank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2204864" y="4499992"/>
            <a:ext cx="25519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100" dirty="0"/>
          </a:p>
        </p:txBody>
      </p:sp>
      <p:sp>
        <p:nvSpPr>
          <p:cNvPr id="14" name="正方形/長方形 13"/>
          <p:cNvSpPr/>
          <p:nvPr/>
        </p:nvSpPr>
        <p:spPr>
          <a:xfrm>
            <a:off x="2204864" y="4643833"/>
            <a:ext cx="25519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12019643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66763" y="187986"/>
            <a:ext cx="56131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The list of tested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ACC response in 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. </a:t>
            </a:r>
            <a:r>
              <a:rPr lang="en-US" altLang="ja-JP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zoensis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579009"/>
              </p:ext>
            </p:extLst>
          </p:nvPr>
        </p:nvGraphicFramePr>
        <p:xfrm>
          <a:off x="287992" y="779878"/>
          <a:ext cx="6957432" cy="1050930"/>
        </p:xfrm>
        <a:graphic>
          <a:graphicData uri="http://schemas.openxmlformats.org/drawingml/2006/table">
            <a:tbl>
              <a:tblPr/>
              <a:tblGrid>
                <a:gridCol w="1271789"/>
                <a:gridCol w="1136375"/>
                <a:gridCol w="1781258"/>
                <a:gridCol w="2768010"/>
              </a:tblGrid>
              <a:tr h="150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ntig_</a:t>
                      </a:r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3528_g8098</a:t>
                      </a: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T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Glycosyltransfera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Glycosyltransferase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family GT14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ntig_39034_g907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VWA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Multiprotein complexes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VWA domain-containing protein</a:t>
                      </a: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ntig_3234_g68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VWA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ultiprotein complexes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</a:t>
                      </a:r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VWA domain-containing protein</a:t>
                      </a: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ntig_48204_g1036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</a:t>
                      </a:r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Plastid transcriptio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RNA polymerase sigma facto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ntig_10995_g262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sbQ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Photosystem II</a:t>
                      </a: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Oxygen-evolving enhancer protein</a:t>
                      </a: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02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ontig_11106_g265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l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ell wall organization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Alginate lyase 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7515" marR="7515" marT="75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cxnSp>
        <p:nvCxnSpPr>
          <p:cNvPr id="6" name="直線コネクタ 5"/>
          <p:cNvCxnSpPr/>
          <p:nvPr/>
        </p:nvCxnSpPr>
        <p:spPr>
          <a:xfrm>
            <a:off x="261368" y="755576"/>
            <a:ext cx="64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260648" y="488132"/>
            <a:ext cx="64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正方形/長方形 8"/>
          <p:cNvSpPr/>
          <p:nvPr/>
        </p:nvSpPr>
        <p:spPr>
          <a:xfrm>
            <a:off x="432048" y="467544"/>
            <a:ext cx="573325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 </a:t>
            </a:r>
            <a:r>
              <a:rPr lang="en-US" altLang="ja-JP" sz="1100" dirty="0" err="1" smtClean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Contig</a:t>
            </a:r>
            <a:r>
              <a:rPr lang="en-US" altLang="ja-JP" sz="1100" dirty="0" smtClean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 </a:t>
            </a:r>
            <a:r>
              <a:rPr lang="en-US" altLang="ja-JP" sz="1100" dirty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ID   </a:t>
            </a:r>
            <a:r>
              <a:rPr lang="en-US" altLang="ja-JP" sz="1100" dirty="0" smtClean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             Abbreviation    </a:t>
            </a:r>
            <a:r>
              <a:rPr lang="ja-JP" altLang="en-US" sz="1100" dirty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 </a:t>
            </a:r>
            <a:r>
              <a:rPr lang="ja-JP" altLang="en-US" sz="1100" dirty="0" smtClean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  </a:t>
            </a:r>
            <a:r>
              <a:rPr lang="en-US" altLang="ja-JP" sz="1100" dirty="0" smtClean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Functional </a:t>
            </a:r>
            <a:r>
              <a:rPr lang="en-US" altLang="ja-JP" sz="1100" dirty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categories   </a:t>
            </a:r>
            <a:r>
              <a:rPr lang="en-US" altLang="ja-JP" sz="1100" dirty="0" smtClean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               Description</a:t>
            </a:r>
            <a:r>
              <a:rPr lang="ja-JP" altLang="en-US" sz="1100" dirty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　</a:t>
            </a:r>
            <a:r>
              <a:rPr lang="en-US" altLang="ja-JP" sz="1100" dirty="0" smtClean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 </a:t>
            </a:r>
            <a:r>
              <a:rPr lang="ja-JP" altLang="en-US" sz="1100" dirty="0">
                <a:latin typeface="Times New Roman" pitchFamily="18" charset="0"/>
                <a:ea typeface="ＭＳ 明朝" pitchFamily="17" charset="-128"/>
                <a:cs typeface="Times New Roman" pitchFamily="18" charset="0"/>
              </a:rPr>
              <a:t>　</a:t>
            </a:r>
            <a:endParaRPr lang="ja-JP" altLang="en-US" sz="1100" dirty="0"/>
          </a:p>
        </p:txBody>
      </p:sp>
      <p:cxnSp>
        <p:nvCxnSpPr>
          <p:cNvPr id="11" name="直線コネクタ 10"/>
          <p:cNvCxnSpPr/>
          <p:nvPr/>
        </p:nvCxnSpPr>
        <p:spPr>
          <a:xfrm>
            <a:off x="252697" y="1899753"/>
            <a:ext cx="648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08861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74</TotalTime>
  <Words>166</Words>
  <Application>Microsoft Office PowerPoint</Application>
  <PresentationFormat>画面に合わせる (4:3)</PresentationFormat>
  <Paragraphs>91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​​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uji</dc:creator>
  <cp:lastModifiedBy>toshiuji</cp:lastModifiedBy>
  <cp:revision>46</cp:revision>
  <dcterms:created xsi:type="dcterms:W3CDTF">2019-09-02T10:34:47Z</dcterms:created>
  <dcterms:modified xsi:type="dcterms:W3CDTF">2021-10-21T00:45:36Z</dcterms:modified>
</cp:coreProperties>
</file>